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99" r:id="rId2"/>
    <p:sldId id="301" r:id="rId3"/>
    <p:sldId id="300" r:id="rId4"/>
    <p:sldId id="295" r:id="rId5"/>
    <p:sldId id="296" r:id="rId6"/>
    <p:sldId id="287" r:id="rId7"/>
    <p:sldId id="284" r:id="rId8"/>
    <p:sldId id="290" r:id="rId9"/>
    <p:sldId id="291" r:id="rId10"/>
    <p:sldId id="294" r:id="rId11"/>
    <p:sldId id="288" r:id="rId1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96">
          <p15:clr>
            <a:srgbClr val="A4A3A4"/>
          </p15:clr>
        </p15:guide>
        <p15:guide id="2" pos="232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brahim Abdelgawad" initials="IA" lastIdx="4" clrIdx="0">
    <p:extLst>
      <p:ext uri="{19B8F6BF-5375-455C-9EA6-DF929625EA0E}">
        <p15:presenceInfo xmlns:p15="http://schemas.microsoft.com/office/powerpoint/2012/main" userId="Ibrahim Abdelgawa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598"/>
    <a:srgbClr val="E6B8B7"/>
    <a:srgbClr val="C5E0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75" autoAdjust="0"/>
    <p:restoredTop sz="83302" autoAdjust="0"/>
  </p:normalViewPr>
  <p:slideViewPr>
    <p:cSldViewPr>
      <p:cViewPr varScale="1">
        <p:scale>
          <a:sx n="112" d="100"/>
          <a:sy n="112" d="100"/>
        </p:scale>
        <p:origin x="126" y="960"/>
      </p:cViewPr>
      <p:guideLst>
        <p:guide orient="horz" pos="896"/>
        <p:guide pos="232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3964F5-FE47-4219-BCD6-3C50F37D1893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9E7E4F-D192-4CE4-AF48-494710D7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71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71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057811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03440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3349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71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43388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16868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71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739619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5961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7424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23166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9793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9E7E4F-D192-4CE4-AF48-494710D77FA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7941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675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89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92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686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367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404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00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119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963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543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835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3F414-168A-4CF7-B42A-8F56922B0D39}" type="datetimeFigureOut">
              <a:rPr lang="en-US" smtClean="0"/>
              <a:t>2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6B0996-55E5-45E4-AFE9-9169919F8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861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jpg"/><Relationship Id="rId3" Type="http://schemas.openxmlformats.org/officeDocument/2006/relationships/image" Target="../media/image54.jpg"/><Relationship Id="rId7" Type="http://schemas.openxmlformats.org/officeDocument/2006/relationships/image" Target="../media/image58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jpg"/><Relationship Id="rId5" Type="http://schemas.openxmlformats.org/officeDocument/2006/relationships/image" Target="../media/image56.jpg"/><Relationship Id="rId4" Type="http://schemas.openxmlformats.org/officeDocument/2006/relationships/image" Target="../media/image55.jp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jpg"/><Relationship Id="rId3" Type="http://schemas.openxmlformats.org/officeDocument/2006/relationships/image" Target="../media/image60.jpg"/><Relationship Id="rId7" Type="http://schemas.openxmlformats.org/officeDocument/2006/relationships/image" Target="../media/image64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jpg"/><Relationship Id="rId5" Type="http://schemas.openxmlformats.org/officeDocument/2006/relationships/image" Target="../media/image62.jpg"/><Relationship Id="rId10" Type="http://schemas.openxmlformats.org/officeDocument/2006/relationships/image" Target="../media/image67.jpg"/><Relationship Id="rId4" Type="http://schemas.openxmlformats.org/officeDocument/2006/relationships/image" Target="../media/image61.jpg"/><Relationship Id="rId9" Type="http://schemas.openxmlformats.org/officeDocument/2006/relationships/image" Target="../media/image66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12" Type="http://schemas.openxmlformats.org/officeDocument/2006/relationships/image" Target="../media/image16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g"/><Relationship Id="rId11" Type="http://schemas.openxmlformats.org/officeDocument/2006/relationships/image" Target="../media/image15.jpg"/><Relationship Id="rId5" Type="http://schemas.openxmlformats.org/officeDocument/2006/relationships/image" Target="../media/image9.jpg"/><Relationship Id="rId10" Type="http://schemas.openxmlformats.org/officeDocument/2006/relationships/image" Target="../media/image14.jpg"/><Relationship Id="rId4" Type="http://schemas.openxmlformats.org/officeDocument/2006/relationships/image" Target="../media/image8.jpg"/><Relationship Id="rId9" Type="http://schemas.openxmlformats.org/officeDocument/2006/relationships/image" Target="../media/image1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3" Type="http://schemas.openxmlformats.org/officeDocument/2006/relationships/image" Target="../media/image17.jpg"/><Relationship Id="rId7" Type="http://schemas.openxmlformats.org/officeDocument/2006/relationships/image" Target="../media/image20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g"/><Relationship Id="rId5" Type="http://schemas.openxmlformats.org/officeDocument/2006/relationships/image" Target="../media/image18.jpg"/><Relationship Id="rId10" Type="http://schemas.openxmlformats.org/officeDocument/2006/relationships/image" Target="../media/image22.jpg"/><Relationship Id="rId4" Type="http://schemas.openxmlformats.org/officeDocument/2006/relationships/image" Target="../media/image10.jpg"/><Relationship Id="rId9" Type="http://schemas.openxmlformats.org/officeDocument/2006/relationships/image" Target="../media/image2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jpg"/><Relationship Id="rId5" Type="http://schemas.openxmlformats.org/officeDocument/2006/relationships/image" Target="../media/image25.jpg"/><Relationship Id="rId4" Type="http://schemas.openxmlformats.org/officeDocument/2006/relationships/image" Target="../media/image24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jpg"/><Relationship Id="rId3" Type="http://schemas.openxmlformats.org/officeDocument/2006/relationships/image" Target="../media/image27.jpg"/><Relationship Id="rId7" Type="http://schemas.openxmlformats.org/officeDocument/2006/relationships/image" Target="../media/image31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jpg"/><Relationship Id="rId5" Type="http://schemas.openxmlformats.org/officeDocument/2006/relationships/image" Target="../media/image29.jpg"/><Relationship Id="rId4" Type="http://schemas.openxmlformats.org/officeDocument/2006/relationships/image" Target="../media/image28.jpg"/><Relationship Id="rId9" Type="http://schemas.openxmlformats.org/officeDocument/2006/relationships/image" Target="../media/image33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g"/><Relationship Id="rId3" Type="http://schemas.openxmlformats.org/officeDocument/2006/relationships/image" Target="../media/image34.jpg"/><Relationship Id="rId7" Type="http://schemas.openxmlformats.org/officeDocument/2006/relationships/image" Target="../media/image38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jpg"/><Relationship Id="rId5" Type="http://schemas.openxmlformats.org/officeDocument/2006/relationships/image" Target="../media/image36.jpg"/><Relationship Id="rId4" Type="http://schemas.openxmlformats.org/officeDocument/2006/relationships/image" Target="../media/image35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jpg"/><Relationship Id="rId5" Type="http://schemas.openxmlformats.org/officeDocument/2006/relationships/image" Target="../media/image27.jpg"/><Relationship Id="rId4" Type="http://schemas.openxmlformats.org/officeDocument/2006/relationships/image" Target="../media/image41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jpg"/><Relationship Id="rId5" Type="http://schemas.openxmlformats.org/officeDocument/2006/relationships/image" Target="../media/image44.jpg"/><Relationship Id="rId4" Type="http://schemas.openxmlformats.org/officeDocument/2006/relationships/image" Target="../media/image43.jp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jpg"/><Relationship Id="rId3" Type="http://schemas.openxmlformats.org/officeDocument/2006/relationships/image" Target="../media/image46.jpg"/><Relationship Id="rId7" Type="http://schemas.openxmlformats.org/officeDocument/2006/relationships/image" Target="../media/image50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jpg"/><Relationship Id="rId5" Type="http://schemas.openxmlformats.org/officeDocument/2006/relationships/image" Target="../media/image48.jpg"/><Relationship Id="rId10" Type="http://schemas.openxmlformats.org/officeDocument/2006/relationships/image" Target="../media/image53.jpg"/><Relationship Id="rId4" Type="http://schemas.openxmlformats.org/officeDocument/2006/relationships/image" Target="../media/image47.jpg"/><Relationship Id="rId9" Type="http://schemas.openxmlformats.org/officeDocument/2006/relationships/image" Target="../media/image5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876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B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20803" y="2152485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53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76720" y="319906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8842937"/>
              </p:ext>
            </p:extLst>
          </p:nvPr>
        </p:nvGraphicFramePr>
        <p:xfrm>
          <a:off x="3942627" y="1181372"/>
          <a:ext cx="2426204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401</a:t>
                      </a:r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9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0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9487408"/>
              </p:ext>
            </p:extLst>
          </p:nvPr>
        </p:nvGraphicFramePr>
        <p:xfrm>
          <a:off x="1532310" y="1125421"/>
          <a:ext cx="1395632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4918">
                  <a:extLst>
                    <a:ext uri="{9D8B030D-6E8A-4147-A177-3AD203B41FA5}">
                      <a16:colId xmlns:a16="http://schemas.microsoft.com/office/drawing/2014/main" val="4099336627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92328535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58328245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32236954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49300841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122165316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011503762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211766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2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86456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961900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7717184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117877"/>
              </p:ext>
            </p:extLst>
          </p:nvPr>
        </p:nvGraphicFramePr>
        <p:xfrm>
          <a:off x="2200036" y="3980249"/>
          <a:ext cx="2512132" cy="635759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3180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93246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87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88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89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90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91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92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75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76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77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EA 278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>
                          <a:effectLst/>
                          <a:latin typeface="Calibri" panose="020F0502020204030204" pitchFamily="34" charset="0"/>
                        </a:rPr>
                        <a:t>EA 279</a:t>
                      </a:r>
                    </a:p>
                  </a:txBody>
                  <a:tcPr marL="18856" marR="18856" marT="12571" marB="12571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1" dirty="0">
                          <a:effectLst/>
                          <a:latin typeface="Calibri" panose="020F0502020204030204" pitchFamily="34" charset="0"/>
                        </a:rPr>
                        <a:t>EA 280</a:t>
                      </a:r>
                    </a:p>
                  </a:txBody>
                  <a:tcPr marL="18856" marR="18856" marT="12571" marB="12571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493" r="60304" b="23774"/>
          <a:stretch/>
        </p:blipFill>
        <p:spPr>
          <a:xfrm>
            <a:off x="1744186" y="2009409"/>
            <a:ext cx="1183756" cy="768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936" r="51288" b="30330"/>
          <a:stretch/>
        </p:blipFill>
        <p:spPr>
          <a:xfrm>
            <a:off x="1523619" y="2913105"/>
            <a:ext cx="1452591" cy="7681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/>
          <p:cNvSpPr txBox="1"/>
          <p:nvPr/>
        </p:nvSpPr>
        <p:spPr>
          <a:xfrm>
            <a:off x="176720" y="7474452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20803" y="5224885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53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" t="73417" r="13939" b="8787"/>
          <a:stretch/>
        </p:blipFill>
        <p:spPr>
          <a:xfrm>
            <a:off x="4043217" y="1919406"/>
            <a:ext cx="2349773" cy="7296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163" r="16515" b="4104"/>
          <a:stretch/>
        </p:blipFill>
        <p:spPr>
          <a:xfrm>
            <a:off x="4043217" y="2687506"/>
            <a:ext cx="2349773" cy="7681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774" b="24710"/>
          <a:stretch/>
        </p:blipFill>
        <p:spPr>
          <a:xfrm>
            <a:off x="1730177" y="4751605"/>
            <a:ext cx="2981992" cy="19462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23" b="8787"/>
          <a:stretch/>
        </p:blipFill>
        <p:spPr>
          <a:xfrm>
            <a:off x="1892800" y="6914705"/>
            <a:ext cx="2981992" cy="201706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42809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43925" y="2720530"/>
            <a:ext cx="91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008006" y="609601"/>
            <a:ext cx="889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4D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-104259" y="4648810"/>
            <a:ext cx="818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8576898"/>
              </p:ext>
            </p:extLst>
          </p:nvPr>
        </p:nvGraphicFramePr>
        <p:xfrm>
          <a:off x="946159" y="6530655"/>
          <a:ext cx="2795925" cy="93817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80962">
                  <a:extLst>
                    <a:ext uri="{9D8B030D-6E8A-4147-A177-3AD203B41FA5}">
                      <a16:colId xmlns:a16="http://schemas.microsoft.com/office/drawing/2014/main" val="4193441458"/>
                    </a:ext>
                  </a:extLst>
                </a:gridCol>
                <a:gridCol w="288786">
                  <a:extLst>
                    <a:ext uri="{9D8B030D-6E8A-4147-A177-3AD203B41FA5}">
                      <a16:colId xmlns:a16="http://schemas.microsoft.com/office/drawing/2014/main" val="2334634960"/>
                    </a:ext>
                  </a:extLst>
                </a:gridCol>
                <a:gridCol w="294134">
                  <a:extLst>
                    <a:ext uri="{9D8B030D-6E8A-4147-A177-3AD203B41FA5}">
                      <a16:colId xmlns:a16="http://schemas.microsoft.com/office/drawing/2014/main" val="1486942209"/>
                    </a:ext>
                  </a:extLst>
                </a:gridCol>
                <a:gridCol w="291460">
                  <a:extLst>
                    <a:ext uri="{9D8B030D-6E8A-4147-A177-3AD203B41FA5}">
                      <a16:colId xmlns:a16="http://schemas.microsoft.com/office/drawing/2014/main" val="3279119506"/>
                    </a:ext>
                  </a:extLst>
                </a:gridCol>
                <a:gridCol w="291460">
                  <a:extLst>
                    <a:ext uri="{9D8B030D-6E8A-4147-A177-3AD203B41FA5}">
                      <a16:colId xmlns:a16="http://schemas.microsoft.com/office/drawing/2014/main" val="134413220"/>
                    </a:ext>
                  </a:extLst>
                </a:gridCol>
                <a:gridCol w="118411">
                  <a:extLst>
                    <a:ext uri="{9D8B030D-6E8A-4147-A177-3AD203B41FA5}">
                      <a16:colId xmlns:a16="http://schemas.microsoft.com/office/drawing/2014/main" val="1497631404"/>
                    </a:ext>
                  </a:extLst>
                </a:gridCol>
                <a:gridCol w="307678">
                  <a:extLst>
                    <a:ext uri="{9D8B030D-6E8A-4147-A177-3AD203B41FA5}">
                      <a16:colId xmlns:a16="http://schemas.microsoft.com/office/drawing/2014/main" val="2606899673"/>
                    </a:ext>
                  </a:extLst>
                </a:gridCol>
                <a:gridCol w="307678">
                  <a:extLst>
                    <a:ext uri="{9D8B030D-6E8A-4147-A177-3AD203B41FA5}">
                      <a16:colId xmlns:a16="http://schemas.microsoft.com/office/drawing/2014/main" val="1447582745"/>
                    </a:ext>
                  </a:extLst>
                </a:gridCol>
                <a:gridCol w="307678">
                  <a:extLst>
                    <a:ext uri="{9D8B030D-6E8A-4147-A177-3AD203B41FA5}">
                      <a16:colId xmlns:a16="http://schemas.microsoft.com/office/drawing/2014/main" val="2692178052"/>
                    </a:ext>
                  </a:extLst>
                </a:gridCol>
                <a:gridCol w="307678">
                  <a:extLst>
                    <a:ext uri="{9D8B030D-6E8A-4147-A177-3AD203B41FA5}">
                      <a16:colId xmlns:a16="http://schemas.microsoft.com/office/drawing/2014/main" val="1815210409"/>
                    </a:ext>
                  </a:extLst>
                </a:gridCol>
              </a:tblGrid>
              <a:tr h="11521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09178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4</a:t>
                      </a:r>
                      <a:endParaRPr lang="en-US" sz="5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35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36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37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UV </a:t>
                      </a:r>
                      <a:endParaRPr lang="en-US" sz="500" kern="1200" dirty="0" smtClean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 rtl="0" fontAlgn="ctr"/>
                      <a:r>
                        <a:rPr lang="en-US" sz="50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72</a:t>
                      </a:r>
                      <a:endParaRPr lang="en-US" sz="50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73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74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375</a:t>
                      </a:r>
                      <a:endParaRPr kumimoji="0" lang="en-US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8121974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54818"/>
                  </a:ext>
                </a:extLst>
              </a:tr>
              <a:tr h="2743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703615"/>
                  </a:ext>
                </a:extLst>
              </a:tr>
            </a:tbl>
          </a:graphicData>
        </a:graphic>
      </p:graphicFrame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7339980"/>
              </p:ext>
            </p:extLst>
          </p:nvPr>
        </p:nvGraphicFramePr>
        <p:xfrm>
          <a:off x="3966670" y="1196423"/>
          <a:ext cx="2480934" cy="60805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49309">
                  <a:extLst>
                    <a:ext uri="{9D8B030D-6E8A-4147-A177-3AD203B41FA5}">
                      <a16:colId xmlns:a16="http://schemas.microsoft.com/office/drawing/2014/main" val="4193441458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33463496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86942209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3279119506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3441322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97631404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06899673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47582745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92178052"/>
                    </a:ext>
                  </a:extLst>
                </a:gridCol>
                <a:gridCol w="162633">
                  <a:extLst>
                    <a:ext uri="{9D8B030D-6E8A-4147-A177-3AD203B41FA5}">
                      <a16:colId xmlns:a16="http://schemas.microsoft.com/office/drawing/2014/main" val="1815210409"/>
                    </a:ext>
                  </a:extLst>
                </a:gridCol>
              </a:tblGrid>
              <a:tr h="1111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09178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14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812197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54818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703615"/>
                  </a:ext>
                </a:extLst>
              </a:tr>
            </a:tbl>
          </a:graphicData>
        </a:graphic>
      </p:graphicFrame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4613906"/>
              </p:ext>
            </p:extLst>
          </p:nvPr>
        </p:nvGraphicFramePr>
        <p:xfrm>
          <a:off x="810776" y="119642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7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  <a:r>
                        <a:rPr lang="en-US" sz="500" baseline="0" dirty="0" smtClean="0">
                          <a:effectLst/>
                        </a:rPr>
                        <a:t> 2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44249" y="7482661"/>
            <a:ext cx="91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62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2643" y="8235569"/>
            <a:ext cx="818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633" b="45317"/>
          <a:stretch/>
        </p:blipFill>
        <p:spPr>
          <a:xfrm>
            <a:off x="1138298" y="8066766"/>
            <a:ext cx="2981992" cy="5760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543" b="16280"/>
          <a:stretch/>
        </p:blipFill>
        <p:spPr>
          <a:xfrm>
            <a:off x="957943" y="7505637"/>
            <a:ext cx="2981992" cy="4992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570" b="19090"/>
          <a:stretch/>
        </p:blipFill>
        <p:spPr>
          <a:xfrm>
            <a:off x="760471" y="2114080"/>
            <a:ext cx="2981992" cy="16130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3" b="13471"/>
          <a:stretch/>
        </p:blipFill>
        <p:spPr>
          <a:xfrm>
            <a:off x="3868555" y="2152485"/>
            <a:ext cx="2748060" cy="1536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711" b="35013"/>
          <a:stretch/>
        </p:blipFill>
        <p:spPr>
          <a:xfrm>
            <a:off x="747952" y="4042045"/>
            <a:ext cx="2981992" cy="16514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950" b="23774"/>
          <a:stretch/>
        </p:blipFill>
        <p:spPr>
          <a:xfrm>
            <a:off x="3966670" y="4023157"/>
            <a:ext cx="2779232" cy="165141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99108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04260" y="2304696"/>
            <a:ext cx="81824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9, 92 </a:t>
            </a:r>
          </a:p>
          <a:p>
            <a:pPr algn="ctr"/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-80019" y="5293665"/>
            <a:ext cx="7697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078605" y="609601"/>
            <a:ext cx="7757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6</a:t>
            </a:r>
            <a:endParaRPr lang="en-US" sz="1400" b="1" dirty="0"/>
          </a:p>
        </p:txBody>
      </p:sp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7697434"/>
              </p:ext>
            </p:extLst>
          </p:nvPr>
        </p:nvGraphicFramePr>
        <p:xfrm>
          <a:off x="810776" y="1196423"/>
          <a:ext cx="2798580" cy="76369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 6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4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4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 64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5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5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5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5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5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00B050"/>
                          </a:solidFill>
                          <a:effectLst/>
                        </a:rPr>
                        <a:t>LPS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effectLst/>
                        </a:rPr>
                        <a:t>-</a:t>
                      </a:r>
                      <a:endParaRPr lang="en-US" sz="700" b="1" dirty="0"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rgbClr val="00B050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rgbClr val="00B050"/>
                        </a:solidFill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effectLst/>
                        </a:rPr>
                        <a:t>-</a:t>
                      </a:r>
                      <a:endParaRPr lang="en-US" sz="700" b="1" dirty="0"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rgbClr val="00B050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rgbClr val="00B050"/>
                        </a:solidFill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90473623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-35936" y="3488630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35936" y="4611660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p65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5788921"/>
              </p:ext>
            </p:extLst>
          </p:nvPr>
        </p:nvGraphicFramePr>
        <p:xfrm>
          <a:off x="3919652" y="1196422"/>
          <a:ext cx="2798580" cy="76369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 68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9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699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700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chemeClr val="tx1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00B050"/>
                          </a:solidFill>
                          <a:effectLst/>
                        </a:rPr>
                        <a:t>LPS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effectLst/>
                        </a:rPr>
                        <a:t>-</a:t>
                      </a:r>
                      <a:endParaRPr lang="en-US" sz="700" b="1" dirty="0"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rgbClr val="00B050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rgbClr val="00B050"/>
                        </a:solidFill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effectLst/>
                        </a:rPr>
                        <a:t>-</a:t>
                      </a:r>
                      <a:endParaRPr lang="en-US" sz="700" b="1" dirty="0"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00" b="1" dirty="0" smtClean="0">
                          <a:solidFill>
                            <a:srgbClr val="00B050"/>
                          </a:solidFill>
                          <a:effectLst/>
                        </a:rPr>
                        <a:t>+</a:t>
                      </a:r>
                      <a:endParaRPr lang="en-US" sz="700" b="1" dirty="0">
                        <a:solidFill>
                          <a:srgbClr val="00B050"/>
                        </a:solidFill>
                        <a:effectLst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/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90473623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7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-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+</a:t>
                      </a:r>
                      <a:endParaRPr kumimoji="0" lang="en-US" sz="7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507" b="32204"/>
          <a:stretch/>
        </p:blipFill>
        <p:spPr>
          <a:xfrm>
            <a:off x="587030" y="3170218"/>
            <a:ext cx="2981992" cy="10369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3" b="40634"/>
          <a:stretch/>
        </p:blipFill>
        <p:spPr>
          <a:xfrm>
            <a:off x="715843" y="5282493"/>
            <a:ext cx="2981992" cy="422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887" b="35013"/>
          <a:stretch/>
        </p:blipFill>
        <p:spPr>
          <a:xfrm>
            <a:off x="3774645" y="3112610"/>
            <a:ext cx="2981992" cy="1152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80" b="44380"/>
          <a:stretch/>
        </p:blipFill>
        <p:spPr>
          <a:xfrm>
            <a:off x="3865053" y="5263290"/>
            <a:ext cx="2981992" cy="4608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569" b="43444"/>
          <a:stretch/>
        </p:blipFill>
        <p:spPr>
          <a:xfrm>
            <a:off x="740650" y="2274455"/>
            <a:ext cx="2981992" cy="614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27" b="67796"/>
          <a:stretch/>
        </p:blipFill>
        <p:spPr>
          <a:xfrm>
            <a:off x="3813050" y="2332063"/>
            <a:ext cx="2981992" cy="4992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620" b="33140"/>
          <a:stretch/>
        </p:blipFill>
        <p:spPr>
          <a:xfrm>
            <a:off x="754248" y="4581285"/>
            <a:ext cx="2981992" cy="4608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444" b="44380"/>
          <a:stretch/>
        </p:blipFill>
        <p:spPr>
          <a:xfrm>
            <a:off x="3851455" y="4562082"/>
            <a:ext cx="2981992" cy="49926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831041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-36853" y="5321172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-36853" y="7312872"/>
            <a:ext cx="68159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060839" y="612578"/>
            <a:ext cx="8703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C</a:t>
            </a:r>
            <a:endParaRPr lang="en-US" sz="1400" b="1" dirty="0"/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4125090"/>
              </p:ext>
            </p:extLst>
          </p:nvPr>
        </p:nvGraphicFramePr>
        <p:xfrm>
          <a:off x="3966670" y="3842305"/>
          <a:ext cx="2426204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401</a:t>
                      </a:r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9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0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830480"/>
              </p:ext>
            </p:extLst>
          </p:nvPr>
        </p:nvGraphicFramePr>
        <p:xfrm>
          <a:off x="4284584" y="1000335"/>
          <a:ext cx="1376546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6592">
                  <a:extLst>
                    <a:ext uri="{9D8B030D-6E8A-4147-A177-3AD203B41FA5}">
                      <a16:colId xmlns:a16="http://schemas.microsoft.com/office/drawing/2014/main" val="3517873167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2964857836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1922297436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4104236890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195563612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3021989344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2678623722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2878080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47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904592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2953675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886553"/>
                  </a:ext>
                </a:extLst>
              </a:tr>
            </a:tbl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570" b="5041"/>
          <a:stretch/>
        </p:blipFill>
        <p:spPr>
          <a:xfrm>
            <a:off x="3874966" y="4610405"/>
            <a:ext cx="2981992" cy="218908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24" b="9723"/>
          <a:stretch/>
        </p:blipFill>
        <p:spPr>
          <a:xfrm>
            <a:off x="3872977" y="6830999"/>
            <a:ext cx="2981992" cy="2150680"/>
          </a:xfrm>
          <a:prstGeom prst="rect">
            <a:avLst/>
          </a:prstGeom>
        </p:spPr>
      </p:pic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8872688"/>
              </p:ext>
            </p:extLst>
          </p:nvPr>
        </p:nvGraphicFramePr>
        <p:xfrm>
          <a:off x="984678" y="1037420"/>
          <a:ext cx="2534726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4918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94984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17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18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19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0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321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322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323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4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5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6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7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328</a:t>
                      </a: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33" b="13470"/>
          <a:stretch/>
        </p:blipFill>
        <p:spPr>
          <a:xfrm>
            <a:off x="907868" y="2050005"/>
            <a:ext cx="2981992" cy="7296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10"/>
          <a:stretch/>
        </p:blipFill>
        <p:spPr>
          <a:xfrm>
            <a:off x="743417" y="2858271"/>
            <a:ext cx="3017248" cy="7920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4" t="81846" b="5977"/>
          <a:stretch/>
        </p:blipFill>
        <p:spPr>
          <a:xfrm>
            <a:off x="4273910" y="2078627"/>
            <a:ext cx="1567806" cy="499265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4" t="70605" b="20028"/>
          <a:stretch/>
        </p:blipFill>
        <p:spPr>
          <a:xfrm>
            <a:off x="4284584" y="3074205"/>
            <a:ext cx="1567806" cy="3840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760" r="47196" b="13471"/>
          <a:stretch/>
        </p:blipFill>
        <p:spPr>
          <a:xfrm>
            <a:off x="587030" y="4761005"/>
            <a:ext cx="1574605" cy="1958655"/>
          </a:xfrm>
          <a:prstGeom prst="rect">
            <a:avLst/>
          </a:prstGeom>
        </p:spPr>
      </p:pic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4675532"/>
              </p:ext>
            </p:extLst>
          </p:nvPr>
        </p:nvGraphicFramePr>
        <p:xfrm>
          <a:off x="634314" y="3842305"/>
          <a:ext cx="1395632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4918">
                  <a:extLst>
                    <a:ext uri="{9D8B030D-6E8A-4147-A177-3AD203B41FA5}">
                      <a16:colId xmlns:a16="http://schemas.microsoft.com/office/drawing/2014/main" val="4099336627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92328535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58328245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32236954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49300841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122165316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011503762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211766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2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33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86456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961900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7717184"/>
                  </a:ext>
                </a:extLst>
              </a:tr>
            </a:tbl>
          </a:graphicData>
        </a:graphic>
      </p:graphicFrame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1" t="36887" r="34545" b="7851"/>
          <a:stretch/>
        </p:blipFill>
        <p:spPr>
          <a:xfrm>
            <a:off x="587030" y="6770632"/>
            <a:ext cx="1382580" cy="2265895"/>
          </a:xfrm>
          <a:prstGeom prst="rect">
            <a:avLst/>
          </a:prstGeom>
        </p:spPr>
      </p:pic>
      <p:graphicFrame>
        <p:nvGraphicFramePr>
          <p:cNvPr id="25" name="Table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5642563"/>
              </p:ext>
            </p:extLst>
          </p:nvPr>
        </p:nvGraphicFramePr>
        <p:xfrm>
          <a:off x="2377349" y="3842305"/>
          <a:ext cx="1395632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4918">
                  <a:extLst>
                    <a:ext uri="{9D8B030D-6E8A-4147-A177-3AD203B41FA5}">
                      <a16:colId xmlns:a16="http://schemas.microsoft.com/office/drawing/2014/main" val="4099336627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92328535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58328245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322369546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49300841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1221653169"/>
                    </a:ext>
                  </a:extLst>
                </a:gridCol>
                <a:gridCol w="200119">
                  <a:extLst>
                    <a:ext uri="{9D8B030D-6E8A-4147-A177-3AD203B41FA5}">
                      <a16:colId xmlns:a16="http://schemas.microsoft.com/office/drawing/2014/main" val="4011503762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211766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  <a:r>
                        <a:rPr lang="en-US" sz="500" b="1" baseline="0" dirty="0" smtClean="0">
                          <a:effectLst/>
                        </a:rPr>
                        <a:t> 26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26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  <a:r>
                        <a:rPr lang="en-US" sz="500" b="1" baseline="0" dirty="0" smtClean="0">
                          <a:effectLst/>
                        </a:rPr>
                        <a:t> 26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26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  <a:r>
                        <a:rPr lang="en-US" sz="500" b="1" baseline="0" dirty="0" smtClean="0">
                          <a:effectLst/>
                        </a:rPr>
                        <a:t> 26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26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486456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961900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7717184"/>
                  </a:ext>
                </a:extLst>
              </a:tr>
            </a:tbl>
          </a:graphicData>
        </a:graphic>
      </p:graphicFrame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584" r="46136" b="22837"/>
          <a:stretch/>
        </p:blipFill>
        <p:spPr>
          <a:xfrm>
            <a:off x="2200040" y="4740800"/>
            <a:ext cx="1606211" cy="207387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20964" r="44848" b="27520"/>
          <a:stretch/>
        </p:blipFill>
        <p:spPr>
          <a:xfrm>
            <a:off x="2201883" y="6842940"/>
            <a:ext cx="1644616" cy="2112276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-36853" y="2335821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-142665" y="3125984"/>
            <a:ext cx="89322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30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1848" y="5523342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7765" y="3368290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1008006" y="609601"/>
            <a:ext cx="889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D</a:t>
            </a:r>
            <a:endParaRPr lang="en-US" sz="14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810" b="21900"/>
          <a:stretch/>
        </p:blipFill>
        <p:spPr>
          <a:xfrm>
            <a:off x="894270" y="1982537"/>
            <a:ext cx="3427738" cy="10369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10"/>
          <a:stretch/>
        </p:blipFill>
        <p:spPr>
          <a:xfrm>
            <a:off x="1052773" y="3088955"/>
            <a:ext cx="3379898" cy="945375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799169"/>
              </p:ext>
            </p:extLst>
          </p:nvPr>
        </p:nvGraphicFramePr>
        <p:xfrm>
          <a:off x="1360270" y="1031836"/>
          <a:ext cx="2961738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27754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27832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endParaRPr lang="en-US" sz="500" b="1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31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endParaRPr lang="en-US" sz="500" b="1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31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endParaRPr lang="en-US" sz="500" b="1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31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0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1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2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endParaRPr lang="en-US" sz="500" b="1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32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4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5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endParaRPr lang="en-US" sz="500" b="1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32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7</a:t>
                      </a: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EA</a:t>
                      </a:r>
                    </a:p>
                    <a:p>
                      <a:pPr algn="ctr" rtl="0" fontAlgn="ctr"/>
                      <a:r>
                        <a:rPr lang="en-US" sz="500" b="1" dirty="0" smtClean="0">
                          <a:effectLst/>
                        </a:rPr>
                        <a:t> </a:t>
                      </a:r>
                      <a:r>
                        <a:rPr lang="en-US" sz="500" b="1" dirty="0">
                          <a:effectLst/>
                        </a:rPr>
                        <a:t>328</a:t>
                      </a: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0596152"/>
              </p:ext>
            </p:extLst>
          </p:nvPr>
        </p:nvGraphicFramePr>
        <p:xfrm>
          <a:off x="1064971" y="4097308"/>
          <a:ext cx="2479243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0651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90716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197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198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199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0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1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2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3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4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5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6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>
                          <a:effectLst/>
                        </a:rPr>
                        <a:t>EA 207</a:t>
                      </a: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208</a:t>
                      </a:r>
                    </a:p>
                  </a:txBody>
                  <a:tcPr marL="22860" marR="2286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3"/>
          <a:stretch/>
        </p:blipFill>
        <p:spPr>
          <a:xfrm>
            <a:off x="826062" y="4801193"/>
            <a:ext cx="2981992" cy="19982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150"/>
          <a:stretch/>
        </p:blipFill>
        <p:spPr>
          <a:xfrm>
            <a:off x="817460" y="6963876"/>
            <a:ext cx="2981992" cy="21015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/>
          <p:cNvSpPr txBox="1"/>
          <p:nvPr/>
        </p:nvSpPr>
        <p:spPr>
          <a:xfrm>
            <a:off x="131848" y="2264363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7765" y="7567590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4" t="63113" b="8524"/>
          <a:stretch/>
        </p:blipFill>
        <p:spPr>
          <a:xfrm>
            <a:off x="4893530" y="1957287"/>
            <a:ext cx="1567806" cy="11629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24" t="70605" b="20028"/>
          <a:stretch/>
        </p:blipFill>
        <p:spPr>
          <a:xfrm>
            <a:off x="4893530" y="3493487"/>
            <a:ext cx="1567806" cy="38405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056483"/>
              </p:ext>
            </p:extLst>
          </p:nvPr>
        </p:nvGraphicFramePr>
        <p:xfrm>
          <a:off x="4861157" y="1031532"/>
          <a:ext cx="1376546" cy="8677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6592">
                  <a:extLst>
                    <a:ext uri="{9D8B030D-6E8A-4147-A177-3AD203B41FA5}">
                      <a16:colId xmlns:a16="http://schemas.microsoft.com/office/drawing/2014/main" val="3517873167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2964857836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1922297436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4104236890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195563612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3021989344"/>
                    </a:ext>
                  </a:extLst>
                </a:gridCol>
                <a:gridCol w="196659">
                  <a:extLst>
                    <a:ext uri="{9D8B030D-6E8A-4147-A177-3AD203B41FA5}">
                      <a16:colId xmlns:a16="http://schemas.microsoft.com/office/drawing/2014/main" val="2678623722"/>
                    </a:ext>
                  </a:extLst>
                </a:gridCol>
              </a:tblGrid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2878080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47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7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059" marR="1605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1904592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29536757"/>
                  </a:ext>
                </a:extLst>
              </a:tr>
              <a:tr h="2169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886553"/>
                  </a:ext>
                </a:extLst>
              </a:tr>
            </a:tbl>
          </a:graphicData>
        </a:graphic>
      </p:graphicFrame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253" b="21901"/>
          <a:stretch/>
        </p:blipFill>
        <p:spPr>
          <a:xfrm>
            <a:off x="3853100" y="4994455"/>
            <a:ext cx="2981992" cy="130577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0286335"/>
              </p:ext>
            </p:extLst>
          </p:nvPr>
        </p:nvGraphicFramePr>
        <p:xfrm>
          <a:off x="4190411" y="4097308"/>
          <a:ext cx="2426204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86636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b="1" dirty="0">
                          <a:effectLst/>
                        </a:rPr>
                        <a:t>EA </a:t>
                      </a:r>
                      <a:r>
                        <a:rPr lang="en-US" sz="500" b="1" dirty="0" smtClean="0">
                          <a:effectLst/>
                        </a:rPr>
                        <a:t>401</a:t>
                      </a:r>
                      <a:endParaRPr lang="en-US" sz="500" b="1" dirty="0">
                        <a:effectLst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09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0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EA 41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22860" marR="2286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b="0" dirty="0" smtClean="0">
                          <a:effectLst/>
                        </a:rPr>
                        <a:t>0.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3416" b="4104"/>
          <a:stretch/>
        </p:blipFill>
        <p:spPr>
          <a:xfrm>
            <a:off x="3865053" y="7298755"/>
            <a:ext cx="2981992" cy="92172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490419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008006" y="609601"/>
            <a:ext cx="8639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E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-2328" y="2500731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53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2900" y="4766626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Table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2191634"/>
              </p:ext>
            </p:extLst>
          </p:nvPr>
        </p:nvGraphicFramePr>
        <p:xfrm>
          <a:off x="810776" y="119642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7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  <a:r>
                        <a:rPr lang="en-US" sz="500" baseline="0" dirty="0" smtClean="0">
                          <a:effectLst/>
                        </a:rPr>
                        <a:t> 2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36" name="Table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478708"/>
              </p:ext>
            </p:extLst>
          </p:nvPr>
        </p:nvGraphicFramePr>
        <p:xfrm>
          <a:off x="3966670" y="1196423"/>
          <a:ext cx="2480934" cy="60805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49309">
                  <a:extLst>
                    <a:ext uri="{9D8B030D-6E8A-4147-A177-3AD203B41FA5}">
                      <a16:colId xmlns:a16="http://schemas.microsoft.com/office/drawing/2014/main" val="4193441458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33463496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86942209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3279119506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3441322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97631404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06899673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47582745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92178052"/>
                    </a:ext>
                  </a:extLst>
                </a:gridCol>
                <a:gridCol w="162633">
                  <a:extLst>
                    <a:ext uri="{9D8B030D-6E8A-4147-A177-3AD203B41FA5}">
                      <a16:colId xmlns:a16="http://schemas.microsoft.com/office/drawing/2014/main" val="1815210409"/>
                    </a:ext>
                  </a:extLst>
                </a:gridCol>
              </a:tblGrid>
              <a:tr h="1111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09178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14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812197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54818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703615"/>
                  </a:ext>
                </a:extLst>
              </a:tr>
            </a:tbl>
          </a:graphicData>
        </a:graphic>
      </p:graphicFrame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07" b="34077"/>
          <a:stretch/>
        </p:blipFill>
        <p:spPr>
          <a:xfrm>
            <a:off x="740427" y="2101479"/>
            <a:ext cx="2981992" cy="21122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124" b="16550"/>
          <a:stretch/>
        </p:blipFill>
        <p:spPr>
          <a:xfrm>
            <a:off x="3801156" y="2115110"/>
            <a:ext cx="2700244" cy="2227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090" b="27520"/>
          <a:stretch/>
        </p:blipFill>
        <p:spPr>
          <a:xfrm>
            <a:off x="677730" y="4351045"/>
            <a:ext cx="2981992" cy="21890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780" b="10831"/>
          <a:stretch/>
        </p:blipFill>
        <p:spPr>
          <a:xfrm>
            <a:off x="3783257" y="4418380"/>
            <a:ext cx="2718143" cy="218908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9855130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3435" y="6745033"/>
            <a:ext cx="681597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21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-67518" y="7566426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545798" y="4967461"/>
            <a:ext cx="889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G</a:t>
            </a:r>
            <a:endParaRPr lang="en-US" sz="1400" b="1" dirty="0"/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6017271"/>
              </p:ext>
            </p:extLst>
          </p:nvPr>
        </p:nvGraphicFramePr>
        <p:xfrm>
          <a:off x="3780406" y="5562824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556128"/>
              </p:ext>
            </p:extLst>
          </p:nvPr>
        </p:nvGraphicFramePr>
        <p:xfrm>
          <a:off x="732037" y="5562824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865" b="25895"/>
          <a:stretch/>
        </p:blipFill>
        <p:spPr>
          <a:xfrm flipH="1">
            <a:off x="623506" y="7555821"/>
            <a:ext cx="2945516" cy="46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860" b="21900"/>
          <a:stretch/>
        </p:blipFill>
        <p:spPr>
          <a:xfrm>
            <a:off x="3671099" y="7555821"/>
            <a:ext cx="2981992" cy="46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303" b="10660"/>
          <a:stretch/>
        </p:blipFill>
        <p:spPr>
          <a:xfrm flipH="1">
            <a:off x="587030" y="6300225"/>
            <a:ext cx="2981992" cy="11905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493" b="13471"/>
          <a:stretch/>
        </p:blipFill>
        <p:spPr>
          <a:xfrm>
            <a:off x="3686437" y="6269523"/>
            <a:ext cx="2892549" cy="11905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/>
          <p:cNvSpPr txBox="1"/>
          <p:nvPr/>
        </p:nvSpPr>
        <p:spPr>
          <a:xfrm>
            <a:off x="-23435" y="2205230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53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-67518" y="3076076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54427" y="627800"/>
            <a:ext cx="8575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1F</a:t>
            </a:r>
            <a:endParaRPr lang="en-US" sz="1400" b="1" dirty="0"/>
          </a:p>
        </p:txBody>
      </p:sp>
      <p:graphicFrame>
        <p:nvGraphicFramePr>
          <p:cNvPr id="30" name="Tab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8669021"/>
              </p:ext>
            </p:extLst>
          </p:nvPr>
        </p:nvGraphicFramePr>
        <p:xfrm>
          <a:off x="847218" y="1295368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31" name="Table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7354808"/>
              </p:ext>
            </p:extLst>
          </p:nvPr>
        </p:nvGraphicFramePr>
        <p:xfrm>
          <a:off x="3826648" y="1295368"/>
          <a:ext cx="2798579" cy="6106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04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baseline="0" dirty="0" smtClean="0">
                          <a:effectLst/>
                        </a:rPr>
                        <a:t> 5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5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5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5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865" b="25895"/>
          <a:stretch/>
        </p:blipFill>
        <p:spPr>
          <a:xfrm flipH="1">
            <a:off x="707724" y="3076076"/>
            <a:ext cx="2945516" cy="46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973" b="8578"/>
          <a:stretch/>
        </p:blipFill>
        <p:spPr>
          <a:xfrm flipH="1">
            <a:off x="689486" y="2161780"/>
            <a:ext cx="2981992" cy="469432"/>
          </a:xfrm>
          <a:prstGeom prst="rect">
            <a:avLst/>
          </a:prstGeom>
        </p:spPr>
      </p:pic>
      <p:cxnSp>
        <p:nvCxnSpPr>
          <p:cNvPr id="34" name="Straight Connector 33"/>
          <p:cNvCxnSpPr/>
          <p:nvPr/>
        </p:nvCxnSpPr>
        <p:spPr>
          <a:xfrm>
            <a:off x="0" y="4764025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b="30330"/>
          <a:stretch/>
        </p:blipFill>
        <p:spPr>
          <a:xfrm>
            <a:off x="3826648" y="2089983"/>
            <a:ext cx="2981992" cy="80650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127" b="34077"/>
          <a:stretch/>
        </p:blipFill>
        <p:spPr>
          <a:xfrm>
            <a:off x="3841218" y="3005244"/>
            <a:ext cx="2981992" cy="72969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785687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16606" y="2553122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MP-3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6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-27477" y="3277538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054427" y="609601"/>
            <a:ext cx="876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3B</a:t>
            </a:r>
            <a:endParaRPr lang="en-US" sz="1400" b="1" dirty="0"/>
          </a:p>
        </p:txBody>
      </p:sp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9003363"/>
              </p:ext>
            </p:extLst>
          </p:nvPr>
        </p:nvGraphicFramePr>
        <p:xfrm>
          <a:off x="810776" y="119642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  <a:r>
                        <a:rPr lang="en-US" sz="500" baseline="0" dirty="0" smtClean="0">
                          <a:effectLst/>
                        </a:rPr>
                        <a:t> 4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5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5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5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7670219"/>
              </p:ext>
            </p:extLst>
          </p:nvPr>
        </p:nvGraphicFramePr>
        <p:xfrm>
          <a:off x="3904756" y="1196423"/>
          <a:ext cx="2798579" cy="61061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04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27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7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baseline="0" dirty="0" smtClean="0">
                          <a:effectLst/>
                        </a:rPr>
                        <a:t> 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3956836"/>
              </p:ext>
            </p:extLst>
          </p:nvPr>
        </p:nvGraphicFramePr>
        <p:xfrm>
          <a:off x="791653" y="4583121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0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0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0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0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30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30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30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0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baseline="0" dirty="0" smtClean="0">
                          <a:effectLst/>
                        </a:rPr>
                        <a:t> 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6606" y="5389626"/>
            <a:ext cx="68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MP-3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6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-27477" y="6234536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846"/>
          <a:stretch/>
        </p:blipFill>
        <p:spPr>
          <a:xfrm>
            <a:off x="760113" y="3182362"/>
            <a:ext cx="2981992" cy="7443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141" b="49063"/>
          <a:stretch/>
        </p:blipFill>
        <p:spPr>
          <a:xfrm>
            <a:off x="791653" y="2379655"/>
            <a:ext cx="2981992" cy="7296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683" b="27520"/>
          <a:stretch/>
        </p:blipFill>
        <p:spPr>
          <a:xfrm>
            <a:off x="3813050" y="2388329"/>
            <a:ext cx="2981992" cy="7296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493" b="24711"/>
          <a:stretch/>
        </p:blipFill>
        <p:spPr>
          <a:xfrm>
            <a:off x="3865920" y="3182362"/>
            <a:ext cx="2981992" cy="72969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593"/>
          <a:stretch/>
        </p:blipFill>
        <p:spPr>
          <a:xfrm>
            <a:off x="883928" y="6208761"/>
            <a:ext cx="2981992" cy="5907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063" b="34077"/>
          <a:stretch/>
        </p:blipFill>
        <p:spPr>
          <a:xfrm>
            <a:off x="883928" y="5259106"/>
            <a:ext cx="2981992" cy="69129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1974440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74386" y="2553122"/>
            <a:ext cx="11070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CAM-1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89, 92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-5737" y="3277538"/>
            <a:ext cx="76976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118412" y="609601"/>
            <a:ext cx="889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3D</a:t>
            </a:r>
            <a:endParaRPr lang="en-US" sz="1400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6897246"/>
              </p:ext>
            </p:extLst>
          </p:nvPr>
        </p:nvGraphicFramePr>
        <p:xfrm>
          <a:off x="3935955" y="1196423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5992202"/>
              </p:ext>
            </p:extLst>
          </p:nvPr>
        </p:nvGraphicFramePr>
        <p:xfrm>
          <a:off x="937660" y="1196423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4" t="68733" r="1" b="19090"/>
          <a:stretch/>
        </p:blipFill>
        <p:spPr>
          <a:xfrm flipH="1">
            <a:off x="790724" y="2536535"/>
            <a:ext cx="2894779" cy="49926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917" b="24037"/>
          <a:stretch/>
        </p:blipFill>
        <p:spPr>
          <a:xfrm rot="10800000">
            <a:off x="3826648" y="2541949"/>
            <a:ext cx="2981992" cy="4938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865" b="25895"/>
          <a:stretch/>
        </p:blipFill>
        <p:spPr>
          <a:xfrm flipH="1">
            <a:off x="829129" y="3189420"/>
            <a:ext cx="2945516" cy="46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860" b="21900"/>
          <a:stretch/>
        </p:blipFill>
        <p:spPr>
          <a:xfrm>
            <a:off x="3826648" y="3189420"/>
            <a:ext cx="2981992" cy="46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83227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05313" y="2920585"/>
            <a:ext cx="91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JNK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46, 54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123221" y="609601"/>
            <a:ext cx="884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4A</a:t>
            </a:r>
            <a:endParaRPr lang="en-US" sz="1400" b="1" dirty="0"/>
          </a:p>
        </p:txBody>
      </p:sp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103491"/>
              </p:ext>
            </p:extLst>
          </p:nvPr>
        </p:nvGraphicFramePr>
        <p:xfrm>
          <a:off x="964395" y="119642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6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6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7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  <a:r>
                        <a:rPr lang="en-US" sz="500" baseline="0" dirty="0" smtClean="0">
                          <a:effectLst/>
                        </a:rPr>
                        <a:t> 2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06" b="15626"/>
          <a:stretch/>
        </p:blipFill>
        <p:spPr>
          <a:xfrm>
            <a:off x="3957039" y="2152485"/>
            <a:ext cx="2656699" cy="19202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996" r="63" b="28108"/>
          <a:stretch/>
        </p:blipFill>
        <p:spPr>
          <a:xfrm>
            <a:off x="867605" y="2152485"/>
            <a:ext cx="3060660" cy="2227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984" b="18989"/>
          <a:stretch/>
        </p:blipFill>
        <p:spPr>
          <a:xfrm>
            <a:off x="735257" y="4879240"/>
            <a:ext cx="3057195" cy="245791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" t="18131" r="3416" b="30309"/>
          <a:stretch/>
        </p:blipFill>
        <p:spPr>
          <a:xfrm>
            <a:off x="3992220" y="4879240"/>
            <a:ext cx="2649945" cy="21506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/>
          <p:cNvSpPr txBox="1"/>
          <p:nvPr/>
        </p:nvSpPr>
        <p:spPr>
          <a:xfrm>
            <a:off x="-189862" y="5831200"/>
            <a:ext cx="10841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-JNK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46,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1548536"/>
              </p:ext>
            </p:extLst>
          </p:nvPr>
        </p:nvGraphicFramePr>
        <p:xfrm>
          <a:off x="3966670" y="1196423"/>
          <a:ext cx="2480934" cy="60805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49309">
                  <a:extLst>
                    <a:ext uri="{9D8B030D-6E8A-4147-A177-3AD203B41FA5}">
                      <a16:colId xmlns:a16="http://schemas.microsoft.com/office/drawing/2014/main" val="4193441458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33463496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86942209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3279119506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34413220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97631404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06899673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1447582745"/>
                    </a:ext>
                  </a:extLst>
                </a:gridCol>
                <a:gridCol w="258624">
                  <a:extLst>
                    <a:ext uri="{9D8B030D-6E8A-4147-A177-3AD203B41FA5}">
                      <a16:colId xmlns:a16="http://schemas.microsoft.com/office/drawing/2014/main" val="2692178052"/>
                    </a:ext>
                  </a:extLst>
                </a:gridCol>
                <a:gridCol w="162633">
                  <a:extLst>
                    <a:ext uri="{9D8B030D-6E8A-4147-A177-3AD203B41FA5}">
                      <a16:colId xmlns:a16="http://schemas.microsoft.com/office/drawing/2014/main" val="1815210409"/>
                    </a:ext>
                  </a:extLst>
                </a:gridCol>
              </a:tblGrid>
              <a:tr h="11115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109178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14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14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8121974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4554818"/>
                  </a:ext>
                </a:extLst>
              </a:tr>
              <a:tr h="16563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7036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06031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104259" y="2052124"/>
            <a:ext cx="91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3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43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90600" y="304801"/>
            <a:ext cx="1552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ncropped images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1047890" y="609601"/>
            <a:ext cx="8767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4B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-55865" y="2767771"/>
            <a:ext cx="8182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40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4426424"/>
              </p:ext>
            </p:extLst>
          </p:nvPr>
        </p:nvGraphicFramePr>
        <p:xfrm>
          <a:off x="3859145" y="1196423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1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2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1895602"/>
              </p:ext>
            </p:extLst>
          </p:nvPr>
        </p:nvGraphicFramePr>
        <p:xfrm>
          <a:off x="750641" y="1196423"/>
          <a:ext cx="2798580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8657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40958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159929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49725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7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HUV</a:t>
                      </a: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 8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endParaRPr lang="en-US" sz="500" dirty="0" smtClean="0">
                        <a:effectLst/>
                      </a:endParaRPr>
                    </a:p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1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b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100" b="10660"/>
          <a:stretch/>
        </p:blipFill>
        <p:spPr>
          <a:xfrm flipH="1">
            <a:off x="750641" y="2052124"/>
            <a:ext cx="2981992" cy="4608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303" b="27520"/>
          <a:stretch/>
        </p:blipFill>
        <p:spPr>
          <a:xfrm flipH="1">
            <a:off x="702245" y="2708936"/>
            <a:ext cx="2981992" cy="4992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3113" b="23774"/>
          <a:stretch/>
        </p:blipFill>
        <p:spPr>
          <a:xfrm>
            <a:off x="3808065" y="2052124"/>
            <a:ext cx="2981992" cy="5376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50" b="21900"/>
          <a:stretch/>
        </p:blipFill>
        <p:spPr>
          <a:xfrm>
            <a:off x="3808065" y="2690155"/>
            <a:ext cx="2981992" cy="57607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Straight Connector 17"/>
          <p:cNvCxnSpPr/>
          <p:nvPr/>
        </p:nvCxnSpPr>
        <p:spPr>
          <a:xfrm>
            <a:off x="-32948" y="3535065"/>
            <a:ext cx="6890948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-24819" y="5036996"/>
            <a:ext cx="9150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65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80248" y="3603921"/>
            <a:ext cx="8703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igure 4C</a:t>
            </a:r>
            <a:endParaRPr lang="en-US" sz="1400" b="1" dirty="0"/>
          </a:p>
        </p:txBody>
      </p:sp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5227047"/>
              </p:ext>
            </p:extLst>
          </p:nvPr>
        </p:nvGraphicFramePr>
        <p:xfrm>
          <a:off x="857244" y="398055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34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3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3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3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40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41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4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4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27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27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276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27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1058651"/>
              </p:ext>
            </p:extLst>
          </p:nvPr>
        </p:nvGraphicFramePr>
        <p:xfrm>
          <a:off x="3912166" y="3980553"/>
          <a:ext cx="2798579" cy="61095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86572">
                  <a:extLst>
                    <a:ext uri="{9D8B030D-6E8A-4147-A177-3AD203B41FA5}">
                      <a16:colId xmlns:a16="http://schemas.microsoft.com/office/drawing/2014/main" val="12105158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811202688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74982441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086073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681327423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3427838486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21369721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2992953835"/>
                    </a:ext>
                  </a:extLst>
                </a:gridCol>
                <a:gridCol w="193542">
                  <a:extLst>
                    <a:ext uri="{9D8B030D-6E8A-4147-A177-3AD203B41FA5}">
                      <a16:colId xmlns:a16="http://schemas.microsoft.com/office/drawing/2014/main" val="1030254478"/>
                    </a:ext>
                  </a:extLst>
                </a:gridCol>
                <a:gridCol w="121707">
                  <a:extLst>
                    <a:ext uri="{9D8B030D-6E8A-4147-A177-3AD203B41FA5}">
                      <a16:colId xmlns:a16="http://schemas.microsoft.com/office/drawing/2014/main" val="3593142395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028358976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1397717127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506254763"/>
                    </a:ext>
                  </a:extLst>
                </a:gridCol>
                <a:gridCol w="204827">
                  <a:extLst>
                    <a:ext uri="{9D8B030D-6E8A-4147-A177-3AD203B41FA5}">
                      <a16:colId xmlns:a16="http://schemas.microsoft.com/office/drawing/2014/main" val="2775362848"/>
                    </a:ext>
                  </a:extLst>
                </a:gridCol>
                <a:gridCol w="122656">
                  <a:extLst>
                    <a:ext uri="{9D8B030D-6E8A-4147-A177-3AD203B41FA5}">
                      <a16:colId xmlns:a16="http://schemas.microsoft.com/office/drawing/2014/main" val="1776831429"/>
                    </a:ext>
                  </a:extLst>
                </a:gridCol>
              </a:tblGrid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3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5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6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7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8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9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1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2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3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14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1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7574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>
                          <a:effectLst/>
                        </a:rPr>
                        <a:t>HUV </a:t>
                      </a:r>
                      <a:r>
                        <a:rPr lang="en-US" sz="500" dirty="0" smtClean="0">
                          <a:effectLst/>
                        </a:rPr>
                        <a:t>366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67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68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69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7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73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74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7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dirty="0" smtClean="0">
                          <a:effectLst/>
                        </a:rPr>
                        <a:t>ladder</a:t>
                      </a: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+mn-ea"/>
                          <a:cs typeface="+mn-cs"/>
                        </a:rPr>
                        <a:t>HUV 302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UV 303</a:t>
                      </a:r>
                      <a:endParaRPr kumimoji="0" lang="en-US" sz="5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UV 304</a:t>
                      </a:r>
                      <a:endParaRPr kumimoji="0" lang="en-US" sz="5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HUV 305</a:t>
                      </a:r>
                      <a:endParaRPr kumimoji="0" lang="en-US" sz="500" b="1" i="0" u="none" strike="noStrike" kern="120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ladder</a:t>
                      </a:r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653157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DOX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(µM)</a:t>
                      </a:r>
                    </a:p>
                  </a:txBody>
                  <a:tcPr marL="16489" marR="16489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500" dirty="0" smtClean="0">
                          <a:effectLst/>
                        </a:rPr>
                        <a:t>0.5</a:t>
                      </a:r>
                      <a:endParaRPr lang="en-US" sz="500" b="1" dirty="0">
                        <a:solidFill>
                          <a:srgbClr val="FF0000"/>
                        </a:solidFill>
                        <a:effectLst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500" u="none" strike="noStrike" kern="1200" cap="none" spc="0" normalizeH="0" baseline="0" noProof="0" dirty="0" smtClean="0">
                          <a:ln>
                            <a:noFill/>
                          </a:ln>
                          <a:effectLst/>
                          <a:uLnTx/>
                          <a:uFillTx/>
                        </a:rPr>
                        <a:t>0.5</a:t>
                      </a:r>
                      <a:endParaRPr kumimoji="0" lang="en-US" sz="5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/>
                        <a:ea typeface="+mn-ea"/>
                        <a:cs typeface="+mn-cs"/>
                      </a:endParaRPr>
                    </a:p>
                  </a:txBody>
                  <a:tcPr marL="16489" marR="16489" marT="0" marB="0" anchor="ctr"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76176699"/>
                  </a:ext>
                </a:extLst>
              </a:tr>
              <a:tr h="15273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Met</a:t>
                      </a:r>
                    </a:p>
                    <a:p>
                      <a:pPr algn="ctr" rtl="0" fontAlgn="b"/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(</a:t>
                      </a:r>
                      <a:r>
                        <a:rPr lang="en-US" sz="500" dirty="0" err="1" smtClean="0">
                          <a:solidFill>
                            <a:srgbClr val="FF0000"/>
                          </a:solidFill>
                          <a:effectLst/>
                        </a:rPr>
                        <a:t>mM</a:t>
                      </a:r>
                      <a:r>
                        <a:rPr lang="en-US" sz="500" dirty="0" smtClean="0">
                          <a:solidFill>
                            <a:srgbClr val="FF0000"/>
                          </a:solidFill>
                          <a:effectLst/>
                        </a:rPr>
                        <a:t>)</a:t>
                      </a:r>
                    </a:p>
                  </a:txBody>
                  <a:tcPr marL="16489" marR="16489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>
                          <a:effectLst/>
                        </a:rPr>
                        <a:t>0</a:t>
                      </a:r>
                      <a:endParaRPr lang="en-US" sz="500" b="1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>
                          <a:effectLst/>
                        </a:rPr>
                        <a:t>0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2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500" dirty="0" smtClean="0">
                          <a:effectLst/>
                        </a:rPr>
                        <a:t>5</a:t>
                      </a:r>
                      <a:endParaRPr lang="en-US" sz="500" b="1" dirty="0">
                        <a:effectLst/>
                      </a:endParaRPr>
                    </a:p>
                  </a:txBody>
                  <a:tcPr marL="16489" marR="16489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en-US" sz="500" dirty="0">
                        <a:effectLst/>
                      </a:endParaRPr>
                    </a:p>
                  </a:txBody>
                  <a:tcPr marL="16489" marR="16489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420259"/>
                  </a:ext>
                </a:extLst>
              </a:tr>
            </a:tbl>
          </a:graphicData>
        </a:graphic>
      </p:graphicFrame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357" b="-580"/>
          <a:stretch/>
        </p:blipFill>
        <p:spPr>
          <a:xfrm>
            <a:off x="779055" y="6664583"/>
            <a:ext cx="2981992" cy="18132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Box 25"/>
          <p:cNvSpPr txBox="1"/>
          <p:nvPr/>
        </p:nvSpPr>
        <p:spPr>
          <a:xfrm>
            <a:off x="47816" y="7371134"/>
            <a:ext cx="7697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-Tubulin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52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507" b="14407"/>
          <a:stretch/>
        </p:blipFill>
        <p:spPr>
          <a:xfrm>
            <a:off x="782030" y="4669812"/>
            <a:ext cx="2922116" cy="17666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53" b="20027"/>
          <a:stretch/>
        </p:blipFill>
        <p:spPr>
          <a:xfrm>
            <a:off x="3903936" y="6664583"/>
            <a:ext cx="2981992" cy="16532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760" b="20964"/>
          <a:stretch/>
        </p:blipFill>
        <p:spPr>
          <a:xfrm>
            <a:off x="3912165" y="4727419"/>
            <a:ext cx="2890285" cy="165141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016481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66</TotalTime>
  <Words>2413</Words>
  <Application>Microsoft Office PowerPoint</Application>
  <PresentationFormat>On-screen Show (4:3)</PresentationFormat>
  <Paragraphs>1871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ne Grant</dc:creator>
  <cp:lastModifiedBy>Ibrahim Abdelgawad</cp:lastModifiedBy>
  <cp:revision>184</cp:revision>
  <cp:lastPrinted>2023-01-23T22:24:41Z</cp:lastPrinted>
  <dcterms:created xsi:type="dcterms:W3CDTF">2018-11-27T20:50:39Z</dcterms:created>
  <dcterms:modified xsi:type="dcterms:W3CDTF">2023-02-20T02:31:58Z</dcterms:modified>
</cp:coreProperties>
</file>